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005" autoAdjust="0"/>
    <p:restoredTop sz="94660"/>
  </p:normalViewPr>
  <p:slideViewPr>
    <p:cSldViewPr snapToGrid="0">
      <p:cViewPr varScale="1">
        <p:scale>
          <a:sx n="108" d="100"/>
          <a:sy n="108" d="100"/>
        </p:scale>
        <p:origin x="120" y="4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6A584FF-49A2-1DE4-5E79-08E791B28D4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6EC0FE91-8BE3-DFCC-0BE3-B83F6D5A74D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93AC11C-4DBF-92FD-EB7E-73B305639B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32889-3E14-48EB-8974-1D901C3C34F8}" type="datetimeFigureOut">
              <a:rPr kumimoji="1" lang="ja-JP" altLang="en-US" smtClean="0"/>
              <a:t>2024/3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884436B-5265-E0CC-899E-EB511628A6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937E832-011F-FD52-96E4-74B32FC488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74D747-743C-40E1-9F75-FDE77A9A1C4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172930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8D2778A-934A-3364-A9E5-D61864C5CE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C8FC2193-700D-DE30-9C11-B4084A8A37B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15AAC71-9620-D0E2-9E0C-DC68032235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32889-3E14-48EB-8974-1D901C3C34F8}" type="datetimeFigureOut">
              <a:rPr kumimoji="1" lang="ja-JP" altLang="en-US" smtClean="0"/>
              <a:t>2024/3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3341C8F-9A64-3348-2100-9E4C049AC7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065104C-DA64-E96F-1B99-B1787218F5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74D747-743C-40E1-9F75-FDE77A9A1C4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465911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6AEC848C-1EB3-3E0B-E3FB-1A63D32F6E8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5B2C8E33-F456-64C5-6E43-075E4314700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2B410FF-9D48-A3D6-A4D0-B4B23950AA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32889-3E14-48EB-8974-1D901C3C34F8}" type="datetimeFigureOut">
              <a:rPr kumimoji="1" lang="ja-JP" altLang="en-US" smtClean="0"/>
              <a:t>2024/3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2194D3F-E52F-4C2B-5A5B-D90AE1A275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14AD742-F151-B506-4154-FAF4412635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74D747-743C-40E1-9F75-FDE77A9A1C4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011983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329EAC5-7687-FE6B-B593-B107F90F420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EFBD74A9-B803-CCC9-795D-4D049989E3D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ADB685E-422C-09B3-DF53-F8CF6AF209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32889-3E14-48EB-8974-1D901C3C34F8}" type="datetimeFigureOut">
              <a:rPr kumimoji="1" lang="ja-JP" altLang="en-US" smtClean="0"/>
              <a:t>2024/3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057B6B8-2FE2-10F7-DE9F-0297758EB7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249932B-7A69-17EA-AB9A-044FE98DC2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74D747-743C-40E1-9F75-FDE77A9A1C4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945443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4257DB7-F96A-D4E7-4E08-CAD485A401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41CEBD86-933B-EB3E-EAC7-FF76008BA5D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12991BE-0764-A991-2024-4AF0C36A2E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32889-3E14-48EB-8974-1D901C3C34F8}" type="datetimeFigureOut">
              <a:rPr kumimoji="1" lang="ja-JP" altLang="en-US" smtClean="0"/>
              <a:t>2024/3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F047631-7E82-9BFD-C765-2CDC34811B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7DB025D-92D7-1677-9E05-A22B77D5F3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74D747-743C-40E1-9F75-FDE77A9A1C4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87589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DB27F21-7A1D-E817-5CBB-77389933FB6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C9E42105-BF47-53FD-D5D2-3FA2EF61E31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10477262-2500-B05A-54CD-F93146794B5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E59A0C0C-DFAB-7759-ECD2-C85A7F7FCA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32889-3E14-48EB-8974-1D901C3C34F8}" type="datetimeFigureOut">
              <a:rPr kumimoji="1" lang="ja-JP" altLang="en-US" smtClean="0"/>
              <a:t>2024/3/2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5A2FC692-C592-F840-923C-0AC45DEE68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10429C20-0236-E990-54EC-1E4350487C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74D747-743C-40E1-9F75-FDE77A9A1C4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140278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6F6B28C-8A5A-8D2E-1856-1C0E3DA1FE1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7A2D0ECA-D83E-8B14-1D2A-3D4838E6D40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9904181C-39BC-E0D4-0EC3-ABCAFFE430D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E87DF30C-4A25-967F-C438-178B812D2B4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BC1CC019-68DB-58EE-112F-B22C495CA12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C4FB3BA6-2827-2CA3-E5D0-53CC5B412E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32889-3E14-48EB-8974-1D901C3C34F8}" type="datetimeFigureOut">
              <a:rPr kumimoji="1" lang="ja-JP" altLang="en-US" smtClean="0"/>
              <a:t>2024/3/21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2E0C6840-B9F7-F2BF-B80F-AEC7D1CD1F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F8769955-ED16-4D6F-DD44-832832EB57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74D747-743C-40E1-9F75-FDE77A9A1C4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44485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22D5E86-57A7-019E-1A85-686A7F5365C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DDD53B8E-283D-3F78-197D-2F07142A14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32889-3E14-48EB-8974-1D901C3C34F8}" type="datetimeFigureOut">
              <a:rPr kumimoji="1" lang="ja-JP" altLang="en-US" smtClean="0"/>
              <a:t>2024/3/21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6261FA00-6AB4-D18D-361F-CA77DE8190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20E6D804-D89E-F793-9153-9FB9FD6CAB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74D747-743C-40E1-9F75-FDE77A9A1C4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252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66EDBBC9-776A-DDE2-E164-461D572FF8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32889-3E14-48EB-8974-1D901C3C34F8}" type="datetimeFigureOut">
              <a:rPr kumimoji="1" lang="ja-JP" altLang="en-US" smtClean="0"/>
              <a:t>2024/3/21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F0D1A60D-A4BE-CBDF-E0A4-62F1F5B8FC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063A8B32-7DA3-EA31-3963-7AE339121E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74D747-743C-40E1-9F75-FDE77A9A1C4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233345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E5AF4EB-8743-2FAD-4F4E-FCA6B5CAAC9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0848083-BDA7-FE00-5085-F09FB08F29A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78A72FF6-CD48-8805-116C-1E8940C7F4A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58AB57A9-377B-0662-E241-A098B436AA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32889-3E14-48EB-8974-1D901C3C34F8}" type="datetimeFigureOut">
              <a:rPr kumimoji="1" lang="ja-JP" altLang="en-US" smtClean="0"/>
              <a:t>2024/3/2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D0ED9DC0-CAE7-9D95-EF7C-C105C5D43F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67492CF0-E5F0-0212-D30C-7FFC70490E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74D747-743C-40E1-9F75-FDE77A9A1C4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350337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E89D402-9EA9-F660-04F9-568EB0795D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CF8F5B5F-3BC5-E3D4-DE10-9711EDC991C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4068E0CC-A824-554D-1794-28FFF1B511A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75597B69-9A13-8196-F6CC-D35AA582D2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32889-3E14-48EB-8974-1D901C3C34F8}" type="datetimeFigureOut">
              <a:rPr kumimoji="1" lang="ja-JP" altLang="en-US" smtClean="0"/>
              <a:t>2024/3/2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F505AD4A-B3B5-12BD-9CFA-6228B32AD6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FD8759DE-70DD-7E6A-5057-414DA4F7DF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74D747-743C-40E1-9F75-FDE77A9A1C4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66811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AD8F6A26-D969-5505-3FE8-1DA7299B78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805AB325-D862-DFD2-BD38-B3949095E07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E949120-A90A-6835-042E-3CC9BF59BC9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C32889-3E14-48EB-8974-1D901C3C34F8}" type="datetimeFigureOut">
              <a:rPr kumimoji="1" lang="ja-JP" altLang="en-US" smtClean="0"/>
              <a:t>2024/3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78FC23A-CBE5-8B97-02F2-75BC2068105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D64CB32-FF74-C1CB-441C-C7639A1F37F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74D747-743C-40E1-9F75-FDE77A9A1C4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65371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49350CB9-659E-3122-A067-7BF66C9A12E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0599" y="218124"/>
            <a:ext cx="8876957" cy="6450105"/>
          </a:xfrm>
          <a:prstGeom prst="rect">
            <a:avLst/>
          </a:prstGeom>
        </p:spPr>
      </p:pic>
      <p:sp>
        <p:nvSpPr>
          <p:cNvPr id="12" name="正方形/長方形 11">
            <a:extLst>
              <a:ext uri="{FF2B5EF4-FFF2-40B4-BE49-F238E27FC236}">
                <a16:creationId xmlns:a16="http://schemas.microsoft.com/office/drawing/2014/main" id="{24699A58-B6C1-B294-3DC7-A70E0D589E61}"/>
              </a:ext>
            </a:extLst>
          </p:cNvPr>
          <p:cNvSpPr/>
          <p:nvPr/>
        </p:nvSpPr>
        <p:spPr>
          <a:xfrm>
            <a:off x="722504" y="349605"/>
            <a:ext cx="2711777" cy="183902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" name="正方形/長方形 12">
            <a:extLst>
              <a:ext uri="{FF2B5EF4-FFF2-40B4-BE49-F238E27FC236}">
                <a16:creationId xmlns:a16="http://schemas.microsoft.com/office/drawing/2014/main" id="{2F77728E-1E43-DAE7-32F5-2BD22C36E2DA}"/>
              </a:ext>
            </a:extLst>
          </p:cNvPr>
          <p:cNvSpPr/>
          <p:nvPr/>
        </p:nvSpPr>
        <p:spPr>
          <a:xfrm>
            <a:off x="722504" y="2265488"/>
            <a:ext cx="2711777" cy="183902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" name="正方形/長方形 13">
            <a:extLst>
              <a:ext uri="{FF2B5EF4-FFF2-40B4-BE49-F238E27FC236}">
                <a16:creationId xmlns:a16="http://schemas.microsoft.com/office/drawing/2014/main" id="{B04B5964-726A-D1AF-E829-B75319FF49F4}"/>
              </a:ext>
            </a:extLst>
          </p:cNvPr>
          <p:cNvSpPr/>
          <p:nvPr/>
        </p:nvSpPr>
        <p:spPr>
          <a:xfrm>
            <a:off x="722504" y="4289839"/>
            <a:ext cx="2711777" cy="183902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5" name="直線コネクタ 4">
            <a:extLst>
              <a:ext uri="{FF2B5EF4-FFF2-40B4-BE49-F238E27FC236}">
                <a16:creationId xmlns:a16="http://schemas.microsoft.com/office/drawing/2014/main" id="{E44D0396-A123-6880-A1BB-77201E3754EB}"/>
              </a:ext>
            </a:extLst>
          </p:cNvPr>
          <p:cNvCxnSpPr>
            <a:cxnSpLocks/>
          </p:cNvCxnSpPr>
          <p:nvPr/>
        </p:nvCxnSpPr>
        <p:spPr>
          <a:xfrm>
            <a:off x="352681" y="2310672"/>
            <a:ext cx="86853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" name="直線コネクタ 5">
            <a:extLst>
              <a:ext uri="{FF2B5EF4-FFF2-40B4-BE49-F238E27FC236}">
                <a16:creationId xmlns:a16="http://schemas.microsoft.com/office/drawing/2014/main" id="{A98EBC9C-474B-4214-3362-2EEAF94175CE}"/>
              </a:ext>
            </a:extLst>
          </p:cNvPr>
          <p:cNvCxnSpPr>
            <a:cxnSpLocks/>
          </p:cNvCxnSpPr>
          <p:nvPr/>
        </p:nvCxnSpPr>
        <p:spPr>
          <a:xfrm>
            <a:off x="352680" y="4235887"/>
            <a:ext cx="868535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54C08831-8FF2-FD5A-6054-CE1B4258FB76}"/>
              </a:ext>
            </a:extLst>
          </p:cNvPr>
          <p:cNvSpPr txBox="1"/>
          <p:nvPr/>
        </p:nvSpPr>
        <p:spPr>
          <a:xfrm>
            <a:off x="370132" y="442550"/>
            <a:ext cx="2949680" cy="17841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1900"/>
              </a:lnSpc>
            </a:pPr>
            <a:r>
              <a:rPr lang="ja-JP" altLang="ja-JP" sz="1400" kern="100" dirty="0">
                <a:effectLst/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・</a:t>
            </a:r>
            <a:r>
              <a:rPr lang="en-US" altLang="ja-JP" sz="1400" b="1" kern="100" dirty="0">
                <a:effectLst/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Health check-up</a:t>
            </a:r>
          </a:p>
          <a:p>
            <a:pPr>
              <a:lnSpc>
                <a:spcPts val="1900"/>
              </a:lnSpc>
            </a:pPr>
            <a:r>
              <a:rPr lang="ja-JP" altLang="en-US" sz="14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　　</a:t>
            </a:r>
            <a:endParaRPr lang="en-US" altLang="ja-JP" sz="1400" kern="100" dirty="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ts val="1900"/>
              </a:lnSpc>
            </a:pPr>
            <a:r>
              <a:rPr lang="ja-JP" altLang="en-US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　</a:t>
            </a:r>
            <a:r>
              <a:rPr lang="en-US" altLang="ja-JP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National health insurance</a:t>
            </a:r>
          </a:p>
          <a:p>
            <a:pPr>
              <a:lnSpc>
                <a:spcPts val="1900"/>
              </a:lnSpc>
            </a:pPr>
            <a:endParaRPr lang="en-US" altLang="ja-JP" sz="1400" kern="100" dirty="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ts val="1900"/>
              </a:lnSpc>
            </a:pPr>
            <a:r>
              <a:rPr lang="ja-JP" altLang="en-US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　</a:t>
            </a:r>
            <a:r>
              <a:rPr lang="en-US" altLang="ja-JP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Employee insurance(employee)</a:t>
            </a:r>
          </a:p>
          <a:p>
            <a:pPr>
              <a:lnSpc>
                <a:spcPts val="1900"/>
              </a:lnSpc>
            </a:pPr>
            <a:endParaRPr lang="en-US" altLang="ja-JP" sz="1400" kern="100" dirty="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ts val="1900"/>
              </a:lnSpc>
            </a:pPr>
            <a:r>
              <a:rPr lang="ja-JP" altLang="en-US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　</a:t>
            </a:r>
            <a:r>
              <a:rPr lang="en-US" altLang="ja-JP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Employee insurance(family)</a:t>
            </a:r>
            <a:endParaRPr lang="ja-JP" altLang="ja-JP" sz="1400" kern="100" dirty="0">
              <a:effectLst/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48673211-331C-F142-ACE0-ED11649CFAB4}"/>
              </a:ext>
            </a:extLst>
          </p:cNvPr>
          <p:cNvSpPr txBox="1"/>
          <p:nvPr/>
        </p:nvSpPr>
        <p:spPr>
          <a:xfrm>
            <a:off x="370132" y="2385873"/>
            <a:ext cx="2949680" cy="17841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1900"/>
              </a:lnSpc>
            </a:pPr>
            <a:r>
              <a:rPr lang="ja-JP" altLang="ja-JP" sz="1400" kern="100" dirty="0">
                <a:effectLst/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・</a:t>
            </a:r>
            <a:r>
              <a:rPr lang="en-US" altLang="ja-JP" sz="1400" b="1" kern="100" dirty="0">
                <a:effectLst/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Cervical cancer screening</a:t>
            </a:r>
          </a:p>
          <a:p>
            <a:pPr>
              <a:lnSpc>
                <a:spcPts val="1900"/>
              </a:lnSpc>
            </a:pPr>
            <a:r>
              <a:rPr lang="ja-JP" altLang="en-US" sz="14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　　</a:t>
            </a:r>
            <a:endParaRPr lang="en-US" altLang="ja-JP" sz="1400" kern="100" dirty="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ts val="1900"/>
              </a:lnSpc>
            </a:pPr>
            <a:r>
              <a:rPr lang="ja-JP" altLang="en-US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　</a:t>
            </a:r>
            <a:r>
              <a:rPr lang="en-US" altLang="ja-JP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National health insurance</a:t>
            </a:r>
          </a:p>
          <a:p>
            <a:pPr>
              <a:lnSpc>
                <a:spcPts val="1900"/>
              </a:lnSpc>
            </a:pPr>
            <a:endParaRPr lang="en-US" altLang="ja-JP" sz="1400" kern="100" dirty="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ts val="1900"/>
              </a:lnSpc>
            </a:pPr>
            <a:r>
              <a:rPr lang="ja-JP" altLang="en-US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　</a:t>
            </a:r>
            <a:r>
              <a:rPr lang="en-US" altLang="ja-JP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Employee insurance(employee)</a:t>
            </a:r>
          </a:p>
          <a:p>
            <a:pPr>
              <a:lnSpc>
                <a:spcPts val="1900"/>
              </a:lnSpc>
            </a:pPr>
            <a:endParaRPr lang="en-US" altLang="ja-JP" sz="1400" kern="100" dirty="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ts val="1900"/>
              </a:lnSpc>
            </a:pPr>
            <a:r>
              <a:rPr lang="ja-JP" altLang="en-US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　</a:t>
            </a:r>
            <a:r>
              <a:rPr lang="en-US" altLang="ja-JP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Employee insurance(family)</a:t>
            </a:r>
            <a:endParaRPr lang="ja-JP" altLang="ja-JP" sz="1400" kern="100" dirty="0">
              <a:effectLst/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BC4F036A-BBE7-902B-32AD-D82B0056DAB3}"/>
              </a:ext>
            </a:extLst>
          </p:cNvPr>
          <p:cNvSpPr txBox="1"/>
          <p:nvPr/>
        </p:nvSpPr>
        <p:spPr>
          <a:xfrm>
            <a:off x="370132" y="4264987"/>
            <a:ext cx="2949680" cy="17841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1900"/>
              </a:lnSpc>
            </a:pPr>
            <a:r>
              <a:rPr lang="ja-JP" altLang="ja-JP" sz="1400" kern="100" dirty="0">
                <a:effectLst/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・</a:t>
            </a:r>
            <a:r>
              <a:rPr lang="en-US" altLang="ja-JP" sz="1400" b="1" kern="100" dirty="0">
                <a:effectLst/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Breast cancer screening</a:t>
            </a:r>
          </a:p>
          <a:p>
            <a:pPr>
              <a:lnSpc>
                <a:spcPts val="1900"/>
              </a:lnSpc>
            </a:pPr>
            <a:r>
              <a:rPr lang="ja-JP" altLang="en-US" sz="14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　　</a:t>
            </a:r>
            <a:endParaRPr lang="en-US" altLang="ja-JP" sz="1400" kern="100" dirty="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ts val="1900"/>
              </a:lnSpc>
            </a:pPr>
            <a:r>
              <a:rPr lang="ja-JP" altLang="en-US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　</a:t>
            </a:r>
            <a:r>
              <a:rPr lang="en-US" altLang="ja-JP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National health insurance</a:t>
            </a:r>
          </a:p>
          <a:p>
            <a:pPr>
              <a:lnSpc>
                <a:spcPts val="1900"/>
              </a:lnSpc>
            </a:pPr>
            <a:endParaRPr lang="en-US" altLang="ja-JP" sz="1400" kern="100" dirty="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ts val="1900"/>
              </a:lnSpc>
            </a:pPr>
            <a:r>
              <a:rPr lang="ja-JP" altLang="en-US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　</a:t>
            </a:r>
            <a:r>
              <a:rPr lang="en-US" altLang="ja-JP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Employee insurance(employee)</a:t>
            </a:r>
          </a:p>
          <a:p>
            <a:pPr>
              <a:lnSpc>
                <a:spcPts val="1900"/>
              </a:lnSpc>
            </a:pPr>
            <a:endParaRPr lang="en-US" altLang="ja-JP" sz="1400" kern="100" dirty="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ts val="1900"/>
              </a:lnSpc>
            </a:pPr>
            <a:r>
              <a:rPr lang="ja-JP" altLang="en-US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　</a:t>
            </a:r>
            <a:r>
              <a:rPr lang="en-US" altLang="ja-JP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Employee insurance(family)</a:t>
            </a:r>
            <a:endParaRPr lang="ja-JP" altLang="ja-JP" sz="1400" kern="100" dirty="0">
              <a:effectLst/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08333195-9C29-203D-D670-010481421974}"/>
              </a:ext>
            </a:extLst>
          </p:cNvPr>
          <p:cNvSpPr txBox="1"/>
          <p:nvPr/>
        </p:nvSpPr>
        <p:spPr>
          <a:xfrm>
            <a:off x="3427198" y="6395028"/>
            <a:ext cx="6149196" cy="30816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1900"/>
              </a:lnSpc>
            </a:pPr>
            <a:r>
              <a:rPr lang="en-US" altLang="ja-JP" sz="1100" b="1" kern="100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Prevalence ratio (wives undergoing wellness examinations) with 95% confidence intervals</a:t>
            </a:r>
            <a:endParaRPr lang="en-US" altLang="ja-JP" sz="1100" b="1" kern="100" dirty="0">
              <a:effectLst/>
              <a:latin typeface="Times New Roman" panose="02020603050405020304" pitchFamily="18" charset="0"/>
              <a:ea typeface="Meiryo UI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2AF31AAA-A36C-2A79-D9F0-F391FE247EAB}"/>
              </a:ext>
            </a:extLst>
          </p:cNvPr>
          <p:cNvSpPr txBox="1"/>
          <p:nvPr/>
        </p:nvSpPr>
        <p:spPr>
          <a:xfrm rot="10800000">
            <a:off x="-22825" y="887880"/>
            <a:ext cx="428322" cy="4865557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>
              <a:lnSpc>
                <a:spcPts val="1900"/>
              </a:lnSpc>
            </a:pPr>
            <a:r>
              <a:rPr lang="en-US" altLang="ja-JP" sz="1100" b="1" kern="100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Type of wellness examination by medical insurance type of wife</a:t>
            </a:r>
            <a:endParaRPr lang="en-US" altLang="ja-JP" sz="1100" b="1" kern="100" dirty="0">
              <a:effectLst/>
              <a:latin typeface="Times New Roman" panose="02020603050405020304" pitchFamily="18" charset="0"/>
              <a:ea typeface="Meiryo UI" panose="020B0604030504040204" pitchFamily="50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581656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21</TotalTime>
  <Words>85</Words>
  <Application>Microsoft Office PowerPoint</Application>
  <PresentationFormat>ワイド画面</PresentationFormat>
  <Paragraphs>2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渡邊 多永子</dc:creator>
  <cp:lastModifiedBy>多永子 渡邊</cp:lastModifiedBy>
  <cp:revision>27</cp:revision>
  <dcterms:created xsi:type="dcterms:W3CDTF">2023-06-28T12:05:12Z</dcterms:created>
  <dcterms:modified xsi:type="dcterms:W3CDTF">2024-03-21T09:19:09Z</dcterms:modified>
</cp:coreProperties>
</file>